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19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3802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0379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2965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472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4935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4594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731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144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8567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972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182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4B5B9-79DF-3E4C-9B0E-38C1B8665F87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31E0E9-BEB9-B748-9AA9-4B41DE6C1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8233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E8032574-62C5-D941-D950-720FD199E2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8322" y="602818"/>
            <a:ext cx="2527729" cy="119645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15B78E6-D4C4-B8FC-C0A1-8B569F8165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76050" y="607452"/>
            <a:ext cx="2527729" cy="1196459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96D7DBC4-E695-EF13-9D2B-AAB4D121BC8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03778" y="602818"/>
            <a:ext cx="2508422" cy="118732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8BC911B6-2EF4-A296-512B-1572E2097DD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8322" y="2099659"/>
            <a:ext cx="2527730" cy="1196459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0E4603C-68BE-AA6D-2ABF-C8978417C8B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76050" y="2104292"/>
            <a:ext cx="2527728" cy="119645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729257FE-45EA-652E-C399-0A908668203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03778" y="2099659"/>
            <a:ext cx="2527728" cy="1196458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98CB03EA-7512-08C2-0D0A-EDD8104CBDC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8322" y="3601131"/>
            <a:ext cx="2134871" cy="1196459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10099596-C6A3-D522-AB44-827CA387230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80573" y="3616723"/>
            <a:ext cx="2395778" cy="1180867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ECF76191-1E93-C0DB-33C8-31E24EAF4B6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603778" y="3616723"/>
            <a:ext cx="2395778" cy="1196457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5FCB6E5-F9E1-6907-CD3D-475EAE0DB375}"/>
              </a:ext>
            </a:extLst>
          </p:cNvPr>
          <p:cNvSpPr txBox="1"/>
          <p:nvPr/>
        </p:nvSpPr>
        <p:spPr>
          <a:xfrm>
            <a:off x="548322" y="289691"/>
            <a:ext cx="88678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Control 1</a:t>
            </a:r>
            <a:endParaRPr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0DB25F7-4913-76AE-9807-27B6D4E6A9CA}"/>
              </a:ext>
            </a:extLst>
          </p:cNvPr>
          <p:cNvSpPr txBox="1"/>
          <p:nvPr/>
        </p:nvSpPr>
        <p:spPr>
          <a:xfrm>
            <a:off x="3007316" y="289691"/>
            <a:ext cx="88678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Control 2</a:t>
            </a:r>
            <a:endParaRPr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4BCDE54-A54F-7CB0-4DD9-89D0BACD17C7}"/>
              </a:ext>
            </a:extLst>
          </p:cNvPr>
          <p:cNvSpPr txBox="1"/>
          <p:nvPr/>
        </p:nvSpPr>
        <p:spPr>
          <a:xfrm>
            <a:off x="5525361" y="289894"/>
            <a:ext cx="88678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Control 3</a:t>
            </a:r>
            <a:endParaRPr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C8AC84D-97A6-68A8-4CC9-40C3ED73D0D5}"/>
              </a:ext>
            </a:extLst>
          </p:cNvPr>
          <p:cNvSpPr txBox="1"/>
          <p:nvPr/>
        </p:nvSpPr>
        <p:spPr>
          <a:xfrm>
            <a:off x="548322" y="1799277"/>
            <a:ext cx="162736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Low-temperature 1</a:t>
            </a:r>
            <a:endParaRPr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D8D9918-9C3C-9311-F460-59FE3527C5D0}"/>
              </a:ext>
            </a:extLst>
          </p:cNvPr>
          <p:cNvSpPr txBox="1"/>
          <p:nvPr/>
        </p:nvSpPr>
        <p:spPr>
          <a:xfrm>
            <a:off x="548596" y="3339723"/>
            <a:ext cx="183896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High-osmotic stress 1</a:t>
            </a:r>
            <a:endParaRPr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C925341-F2A0-42C3-8024-A0B4E0748BDE}"/>
              </a:ext>
            </a:extLst>
          </p:cNvPr>
          <p:cNvSpPr txBox="1"/>
          <p:nvPr/>
        </p:nvSpPr>
        <p:spPr>
          <a:xfrm>
            <a:off x="3076048" y="1815168"/>
            <a:ext cx="162736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Low-temperature 2</a:t>
            </a:r>
            <a:endParaRPr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D353F0D-7BF3-AEAC-6AEF-32DCAC019E3B}"/>
              </a:ext>
            </a:extLst>
          </p:cNvPr>
          <p:cNvSpPr txBox="1"/>
          <p:nvPr/>
        </p:nvSpPr>
        <p:spPr>
          <a:xfrm>
            <a:off x="5603774" y="1799577"/>
            <a:ext cx="162736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Low-temperature 3</a:t>
            </a:r>
            <a:endParaRPr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8CC2098-C3DE-88A2-1153-541316B1C8CF}"/>
              </a:ext>
            </a:extLst>
          </p:cNvPr>
          <p:cNvSpPr txBox="1"/>
          <p:nvPr/>
        </p:nvSpPr>
        <p:spPr>
          <a:xfrm>
            <a:off x="3076048" y="3339723"/>
            <a:ext cx="183896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High-osmotic stress 2</a:t>
            </a:r>
            <a:endParaRPr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600B505-A64A-6942-D10E-125A7F5EB2DF}"/>
              </a:ext>
            </a:extLst>
          </p:cNvPr>
          <p:cNvSpPr txBox="1"/>
          <p:nvPr/>
        </p:nvSpPr>
        <p:spPr>
          <a:xfrm>
            <a:off x="5558327" y="3339723"/>
            <a:ext cx="183896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High-osmotic stress 3</a:t>
            </a:r>
            <a:endParaRPr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87E83A-7AD7-C363-615C-3D0CBF304050}"/>
              </a:ext>
            </a:extLst>
          </p:cNvPr>
          <p:cNvSpPr txBox="1"/>
          <p:nvPr/>
        </p:nvSpPr>
        <p:spPr>
          <a:xfrm>
            <a:off x="441404" y="5333454"/>
            <a:ext cx="852402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Degradation of RNA.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analyzer profiles of total RNA for degradation levels used in the microarray study.</a:t>
            </a:r>
          </a:p>
        </p:txBody>
      </p:sp>
    </p:spTree>
    <p:extLst>
      <p:ext uri="{BB962C8B-B14F-4D97-AF65-F5344CB8AC3E}">
        <p14:creationId xmlns:p14="http://schemas.microsoft.com/office/powerpoint/2010/main" val="2401245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</TotalTime>
  <Words>42</Words>
  <Application>Microsoft Macintosh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KADA Ayaka</dc:creator>
  <cp:lastModifiedBy>OKADA Ayaka</cp:lastModifiedBy>
  <cp:revision>5</cp:revision>
  <dcterms:created xsi:type="dcterms:W3CDTF">2024-02-27T02:04:52Z</dcterms:created>
  <dcterms:modified xsi:type="dcterms:W3CDTF">2024-03-13T07:47:45Z</dcterms:modified>
</cp:coreProperties>
</file>